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34361438" cy="45720000"/>
  <p:notesSz cx="6858000" cy="9144000"/>
  <p:defaultTextStyle>
    <a:defPPr>
      <a:defRPr lang="zh-CN"/>
    </a:defPPr>
    <a:lvl1pPr marL="0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1pPr>
    <a:lvl2pPr marL="1921932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2pPr>
    <a:lvl3pPr marL="3843863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3pPr>
    <a:lvl4pPr marL="5765795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4pPr>
    <a:lvl5pPr marL="7687727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5pPr>
    <a:lvl6pPr marL="9609658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6pPr>
    <a:lvl7pPr marL="11531590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7pPr>
    <a:lvl8pPr marL="13453521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8pPr>
    <a:lvl9pPr marL="15375453" algn="l" defTabSz="3843863" rtl="0" eaLnBrk="1" latinLnBrk="0" hangingPunct="1">
      <a:defRPr sz="756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513" userDrawn="1">
          <p15:clr>
            <a:srgbClr val="A4A3A4"/>
          </p15:clr>
        </p15:guide>
        <p15:guide id="2" pos="145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93" autoAdjust="0"/>
    <p:restoredTop sz="94660"/>
  </p:normalViewPr>
  <p:slideViewPr>
    <p:cSldViewPr snapToGrid="0" showGuides="1">
      <p:cViewPr>
        <p:scale>
          <a:sx n="25" d="100"/>
          <a:sy n="25" d="100"/>
        </p:scale>
        <p:origin x="2568" y="-2454"/>
      </p:cViewPr>
      <p:guideLst>
        <p:guide orient="horz" pos="14513"/>
        <p:guide pos="145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1188DD-52F4-4D58-8AF7-5D98DE440C41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1143000"/>
            <a:ext cx="2320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DFBFD3-965B-4FAA-8026-536C156E1D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6207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295180" y="7482420"/>
            <a:ext cx="25771079" cy="1591733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4295180" y="24013587"/>
            <a:ext cx="25771079" cy="1103841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0759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6886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9304516" y="16224254"/>
            <a:ext cx="20880839" cy="25830741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657530" y="16224254"/>
            <a:ext cx="62217468" cy="25830741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759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322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44452" y="11398257"/>
            <a:ext cx="29636740" cy="1901824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344452" y="30596423"/>
            <a:ext cx="29636740" cy="1000124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097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657530" y="81142423"/>
            <a:ext cx="41546916" cy="19338924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8633964" y="81142423"/>
            <a:ext cx="41551391" cy="19338924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3236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66825" y="2434170"/>
            <a:ext cx="29636740" cy="883708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366826" y="11207753"/>
            <a:ext cx="14536498" cy="549274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366826" y="16700500"/>
            <a:ext cx="14536498" cy="2456392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17395478" y="11207753"/>
            <a:ext cx="14608087" cy="549274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17395478" y="16700500"/>
            <a:ext cx="14608087" cy="2456392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6334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1243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11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66826" y="3048000"/>
            <a:ext cx="11082457" cy="106680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4608087" y="6582837"/>
            <a:ext cx="17395478" cy="324908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66826" y="13716000"/>
            <a:ext cx="11082457" cy="2541058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4515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66826" y="3048000"/>
            <a:ext cx="11082457" cy="106680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4608087" y="6582837"/>
            <a:ext cx="17395478" cy="3249083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66826" y="13716000"/>
            <a:ext cx="11082457" cy="2541058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5955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2362349" y="2434170"/>
            <a:ext cx="29636740" cy="8837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362349" y="12170833"/>
            <a:ext cx="29636740" cy="290089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2362349" y="42375670"/>
            <a:ext cx="7731324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48D76-1066-4F87-A01A-2F2DB593C90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11382227" y="42375670"/>
            <a:ext cx="11596985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24267765" y="42375670"/>
            <a:ext cx="7731324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95461-8523-453C-8042-40C7C08A9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1211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组合 86"/>
          <p:cNvGrpSpPr/>
          <p:nvPr/>
        </p:nvGrpSpPr>
        <p:grpSpPr>
          <a:xfrm>
            <a:off x="651600" y="1016000"/>
            <a:ext cx="10668000" cy="8001000"/>
            <a:chOff x="-487521" y="2560320"/>
            <a:chExt cx="10668000" cy="80010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87521" y="2560320"/>
              <a:ext cx="10668000" cy="8001000"/>
            </a:xfrm>
            <a:prstGeom prst="rect">
              <a:avLst/>
            </a:prstGeom>
          </p:spPr>
        </p:pic>
        <p:cxnSp>
          <p:nvCxnSpPr>
            <p:cNvPr id="23" name="直接连接符 22"/>
            <p:cNvCxnSpPr/>
            <p:nvPr/>
          </p:nvCxnSpPr>
          <p:spPr>
            <a:xfrm>
              <a:off x="3467100" y="4152900"/>
              <a:ext cx="42672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4846479" y="3304319"/>
              <a:ext cx="12618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6" name="组合 85"/>
          <p:cNvGrpSpPr/>
          <p:nvPr/>
        </p:nvGrpSpPr>
        <p:grpSpPr>
          <a:xfrm>
            <a:off x="11588400" y="1016000"/>
            <a:ext cx="10668000" cy="8001000"/>
            <a:chOff x="11587062" y="2561903"/>
            <a:chExt cx="10668000" cy="8001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87062" y="2561903"/>
              <a:ext cx="10668000" cy="8001000"/>
            </a:xfrm>
            <a:prstGeom prst="rect">
              <a:avLst/>
            </a:prstGeom>
          </p:spPr>
        </p:pic>
        <p:cxnSp>
          <p:nvCxnSpPr>
            <p:cNvPr id="26" name="直接连接符 25"/>
            <p:cNvCxnSpPr/>
            <p:nvPr/>
          </p:nvCxnSpPr>
          <p:spPr>
            <a:xfrm>
              <a:off x="15627638" y="4288401"/>
              <a:ext cx="557348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/>
          </p:nvCxnSpPr>
          <p:spPr>
            <a:xfrm>
              <a:off x="13830300" y="3812151"/>
              <a:ext cx="0" cy="34946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>
              <a:off x="13811250" y="3812151"/>
              <a:ext cx="453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>
            <a:xfrm>
              <a:off x="18354797" y="3793101"/>
              <a:ext cx="0" cy="4784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/>
            <p:cNvSpPr txBox="1"/>
            <p:nvPr/>
          </p:nvSpPr>
          <p:spPr>
            <a:xfrm>
              <a:off x="15421765" y="3148913"/>
              <a:ext cx="12618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23572800" y="1016000"/>
            <a:ext cx="10668000" cy="8001000"/>
            <a:chOff x="23693438" y="2618740"/>
            <a:chExt cx="10668000" cy="80010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93438" y="2618740"/>
              <a:ext cx="10668000" cy="8001000"/>
            </a:xfrm>
            <a:prstGeom prst="rect">
              <a:avLst/>
            </a:prstGeom>
          </p:spPr>
        </p:pic>
        <p:grpSp>
          <p:nvGrpSpPr>
            <p:cNvPr id="82" name="组合 81"/>
            <p:cNvGrpSpPr/>
            <p:nvPr/>
          </p:nvGrpSpPr>
          <p:grpSpPr>
            <a:xfrm>
              <a:off x="26128668" y="3091215"/>
              <a:ext cx="7389874" cy="4157876"/>
              <a:chOff x="26128668" y="3091215"/>
              <a:chExt cx="7389874" cy="4157876"/>
            </a:xfrm>
          </p:grpSpPr>
          <p:cxnSp>
            <p:nvCxnSpPr>
              <p:cNvPr id="39" name="直接连接符 38"/>
              <p:cNvCxnSpPr/>
              <p:nvPr/>
            </p:nvCxnSpPr>
            <p:spPr>
              <a:xfrm>
                <a:off x="27945056" y="4378188"/>
                <a:ext cx="557348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26147718" y="3754453"/>
                <a:ext cx="0" cy="349463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26128668" y="3754453"/>
                <a:ext cx="453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30672215" y="3735402"/>
                <a:ext cx="0" cy="61200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文本框 42"/>
              <p:cNvSpPr txBox="1"/>
              <p:nvPr/>
            </p:nvSpPr>
            <p:spPr>
              <a:xfrm>
                <a:off x="27739183" y="3091215"/>
                <a:ext cx="1261884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CN" altLang="en-US" sz="72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</p:grpSp>
      <p:grpSp>
        <p:nvGrpSpPr>
          <p:cNvPr id="79" name="组合 78"/>
          <p:cNvGrpSpPr/>
          <p:nvPr/>
        </p:nvGrpSpPr>
        <p:grpSpPr>
          <a:xfrm>
            <a:off x="651600" y="11362400"/>
            <a:ext cx="10668000" cy="8001000"/>
            <a:chOff x="337156" y="13089523"/>
            <a:chExt cx="10668000" cy="8001000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156" y="13089523"/>
              <a:ext cx="10668000" cy="8001000"/>
            </a:xfrm>
            <a:prstGeom prst="rect">
              <a:avLst/>
            </a:prstGeom>
          </p:spPr>
        </p:pic>
        <p:cxnSp>
          <p:nvCxnSpPr>
            <p:cNvPr id="44" name="直接连接符 43"/>
            <p:cNvCxnSpPr/>
            <p:nvPr/>
          </p:nvCxnSpPr>
          <p:spPr>
            <a:xfrm>
              <a:off x="5983877" y="14447214"/>
              <a:ext cx="3780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3211179" y="13932864"/>
              <a:ext cx="0" cy="4320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>
              <a:off x="3192129" y="13932864"/>
              <a:ext cx="453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/>
          </p:nvCxnSpPr>
          <p:spPr>
            <a:xfrm>
              <a:off x="7735676" y="13951914"/>
              <a:ext cx="0" cy="4784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/>
            <p:cNvSpPr txBox="1"/>
            <p:nvPr/>
          </p:nvSpPr>
          <p:spPr>
            <a:xfrm>
              <a:off x="4802644" y="13307726"/>
              <a:ext cx="12618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0" name="组合 79"/>
          <p:cNvGrpSpPr/>
          <p:nvPr/>
        </p:nvGrpSpPr>
        <p:grpSpPr>
          <a:xfrm>
            <a:off x="11588400" y="11362400"/>
            <a:ext cx="10668000" cy="8001000"/>
            <a:chOff x="12265766" y="12947744"/>
            <a:chExt cx="10668000" cy="8001000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65766" y="12947744"/>
              <a:ext cx="10668000" cy="8001000"/>
            </a:xfrm>
            <a:prstGeom prst="rect">
              <a:avLst/>
            </a:prstGeom>
          </p:spPr>
        </p:pic>
        <p:cxnSp>
          <p:nvCxnSpPr>
            <p:cNvPr id="49" name="直接连接符 48"/>
            <p:cNvCxnSpPr/>
            <p:nvPr/>
          </p:nvCxnSpPr>
          <p:spPr>
            <a:xfrm>
              <a:off x="16315921" y="14152510"/>
              <a:ext cx="557348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>
              <a:off x="14518583" y="13676260"/>
              <a:ext cx="0" cy="4248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14499533" y="13638160"/>
              <a:ext cx="453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/>
          </p:nvCxnSpPr>
          <p:spPr>
            <a:xfrm>
              <a:off x="19043080" y="13657210"/>
              <a:ext cx="0" cy="4784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文本框 52"/>
            <p:cNvSpPr txBox="1"/>
            <p:nvPr/>
          </p:nvSpPr>
          <p:spPr>
            <a:xfrm>
              <a:off x="16007556" y="13449170"/>
              <a:ext cx="1737342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1" name="组合 80"/>
          <p:cNvGrpSpPr/>
          <p:nvPr/>
        </p:nvGrpSpPr>
        <p:grpSpPr>
          <a:xfrm>
            <a:off x="23572800" y="11362400"/>
            <a:ext cx="10668000" cy="8001000"/>
            <a:chOff x="23693438" y="13082637"/>
            <a:chExt cx="10668000" cy="8001000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93438" y="13082637"/>
              <a:ext cx="10668000" cy="8001000"/>
            </a:xfrm>
            <a:prstGeom prst="rect">
              <a:avLst/>
            </a:prstGeom>
          </p:spPr>
        </p:pic>
        <p:cxnSp>
          <p:nvCxnSpPr>
            <p:cNvPr id="54" name="直接连接符 53"/>
            <p:cNvCxnSpPr/>
            <p:nvPr/>
          </p:nvCxnSpPr>
          <p:spPr>
            <a:xfrm>
              <a:off x="27709686" y="14592782"/>
              <a:ext cx="3780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>
              <a:off x="25941845" y="14116532"/>
              <a:ext cx="0" cy="34946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/>
            <p:cNvCxnSpPr/>
            <p:nvPr/>
          </p:nvCxnSpPr>
          <p:spPr>
            <a:xfrm>
              <a:off x="25922795" y="14087035"/>
              <a:ext cx="363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6"/>
            <p:cNvCxnSpPr/>
            <p:nvPr/>
          </p:nvCxnSpPr>
          <p:spPr>
            <a:xfrm>
              <a:off x="29551943" y="14097482"/>
              <a:ext cx="0" cy="4784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/>
            <p:cNvSpPr txBox="1"/>
            <p:nvPr/>
          </p:nvSpPr>
          <p:spPr>
            <a:xfrm>
              <a:off x="26972867" y="13423797"/>
              <a:ext cx="12618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78" name="组合 77"/>
          <p:cNvGrpSpPr/>
          <p:nvPr/>
        </p:nvGrpSpPr>
        <p:grpSpPr>
          <a:xfrm>
            <a:off x="651600" y="21891526"/>
            <a:ext cx="10668000" cy="8001000"/>
            <a:chOff x="337156" y="33667700"/>
            <a:chExt cx="10668000" cy="8001000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156" y="33667700"/>
              <a:ext cx="10668000" cy="8001000"/>
            </a:xfrm>
            <a:prstGeom prst="rect">
              <a:avLst/>
            </a:prstGeom>
          </p:spPr>
        </p:pic>
        <p:grpSp>
          <p:nvGrpSpPr>
            <p:cNvPr id="64" name="组合 63"/>
            <p:cNvGrpSpPr/>
            <p:nvPr/>
          </p:nvGrpSpPr>
          <p:grpSpPr>
            <a:xfrm>
              <a:off x="3114399" y="34450915"/>
              <a:ext cx="6132204" cy="3494638"/>
              <a:chOff x="8947240" y="17199570"/>
              <a:chExt cx="6132204" cy="3494638"/>
            </a:xfrm>
          </p:grpSpPr>
          <p:cxnSp>
            <p:nvCxnSpPr>
              <p:cNvPr id="59" name="直接连接符 58"/>
              <p:cNvCxnSpPr/>
              <p:nvPr/>
            </p:nvCxnSpPr>
            <p:spPr>
              <a:xfrm>
                <a:off x="11983444" y="17793808"/>
                <a:ext cx="309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/>
              <p:cNvCxnSpPr/>
              <p:nvPr/>
            </p:nvCxnSpPr>
            <p:spPr>
              <a:xfrm>
                <a:off x="8947240" y="17199570"/>
                <a:ext cx="0" cy="349463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>
                <a:off x="8957687" y="17229067"/>
                <a:ext cx="453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13471737" y="17269011"/>
                <a:ext cx="0" cy="47840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文本框 62"/>
              <p:cNvSpPr txBox="1"/>
              <p:nvPr/>
            </p:nvSpPr>
            <p:spPr>
              <a:xfrm>
                <a:off x="10538705" y="17303250"/>
                <a:ext cx="1261884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CN" altLang="en-US" sz="72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</p:grpSp>
      <p:grpSp>
        <p:nvGrpSpPr>
          <p:cNvPr id="77" name="组合 76"/>
          <p:cNvGrpSpPr/>
          <p:nvPr/>
        </p:nvGrpSpPr>
        <p:grpSpPr>
          <a:xfrm>
            <a:off x="11588400" y="21891526"/>
            <a:ext cx="10668000" cy="8001000"/>
            <a:chOff x="12035023" y="33385858"/>
            <a:chExt cx="10668000" cy="8001000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35023" y="33385858"/>
              <a:ext cx="10668000" cy="8001000"/>
            </a:xfrm>
            <a:prstGeom prst="rect">
              <a:avLst/>
            </a:prstGeom>
          </p:spPr>
        </p:pic>
        <p:cxnSp>
          <p:nvCxnSpPr>
            <p:cNvPr id="67" name="直接连接符 66"/>
            <p:cNvCxnSpPr/>
            <p:nvPr/>
          </p:nvCxnSpPr>
          <p:spPr>
            <a:xfrm>
              <a:off x="14184975" y="35440757"/>
              <a:ext cx="1980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文本框 68"/>
            <p:cNvSpPr txBox="1"/>
            <p:nvPr/>
          </p:nvSpPr>
          <p:spPr>
            <a:xfrm>
              <a:off x="14614779" y="34780525"/>
              <a:ext cx="12618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70" name="直接连接符 69"/>
            <p:cNvCxnSpPr/>
            <p:nvPr/>
          </p:nvCxnSpPr>
          <p:spPr>
            <a:xfrm>
              <a:off x="14181442" y="34776749"/>
              <a:ext cx="370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文本框 70"/>
            <p:cNvSpPr txBox="1"/>
            <p:nvPr/>
          </p:nvSpPr>
          <p:spPr>
            <a:xfrm>
              <a:off x="15663242" y="34133079"/>
              <a:ext cx="12618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72" name="直接连接符 71"/>
            <p:cNvCxnSpPr/>
            <p:nvPr/>
          </p:nvCxnSpPr>
          <p:spPr>
            <a:xfrm>
              <a:off x="14181442" y="36256104"/>
              <a:ext cx="5580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文本框 72"/>
            <p:cNvSpPr txBox="1"/>
            <p:nvPr/>
          </p:nvSpPr>
          <p:spPr>
            <a:xfrm>
              <a:off x="18889833" y="35648704"/>
              <a:ext cx="902811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75" name="直接连接符 74"/>
            <p:cNvCxnSpPr/>
            <p:nvPr/>
          </p:nvCxnSpPr>
          <p:spPr>
            <a:xfrm>
              <a:off x="14245352" y="36732971"/>
              <a:ext cx="7380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文本框 75"/>
            <p:cNvSpPr txBox="1"/>
            <p:nvPr/>
          </p:nvSpPr>
          <p:spPr>
            <a:xfrm>
              <a:off x="21028699" y="36018796"/>
              <a:ext cx="543739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7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88" name="文本框 87"/>
          <p:cNvSpPr txBox="1"/>
          <p:nvPr/>
        </p:nvSpPr>
        <p:spPr>
          <a:xfrm>
            <a:off x="312419" y="252800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10947992" y="252800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22902240" y="252800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281939" y="10463600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10917512" y="10463600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22932720" y="10463600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221307" y="20383157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10856880" y="20383157"/>
            <a:ext cx="1584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81939" y="30705238"/>
            <a:ext cx="33753517" cy="132959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 figure 1. </a:t>
            </a:r>
            <a:r>
              <a:rPr lang="en-US" altLang="zh-CN" sz="6600" b="1" dirty="0">
                <a:latin typeface="Arial" panose="020B0604020202020204" pitchFamily="34" charset="0"/>
                <a:cs typeface="Arial" panose="020B0604020202020204" pitchFamily="34" charset="0"/>
              </a:rPr>
              <a:t>DFNA5 transcription analysis in subgroups of patients with HNSCC</a:t>
            </a:r>
            <a:r>
              <a:rPr lang="en-US" altLang="zh-CN" sz="6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altLang="zh-CN" sz="6600" dirty="0" smtClean="0"/>
              <a:t>(</a:t>
            </a:r>
            <a:r>
              <a:rPr lang="en-US" altLang="zh-CN" sz="6600" b="1" dirty="0"/>
              <a:t>A</a:t>
            </a:r>
            <a:r>
              <a:rPr lang="en-US" altLang="zh-CN" sz="6600" dirty="0"/>
              <a:t>) Relative expression levels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normal and HNSCC samples. (</a:t>
            </a:r>
            <a:r>
              <a:rPr lang="en-US" altLang="zh-CN" sz="6600" b="1" dirty="0"/>
              <a:t>B</a:t>
            </a:r>
            <a:r>
              <a:rPr lang="en-US" altLang="zh-CN" sz="6600" dirty="0"/>
              <a:t>) Boxplot showing relative expression levels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healthy individuals or in patients with HNSCC at stages 1, 2, 3 or 4. (</a:t>
            </a:r>
            <a:r>
              <a:rPr lang="en-US" altLang="zh-CN" sz="6600" b="1" dirty="0"/>
              <a:t>C</a:t>
            </a:r>
            <a:r>
              <a:rPr lang="en-US" altLang="zh-CN" sz="6600" dirty="0"/>
              <a:t>) Relative expression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healthy individuals of any ethnicity or in HNSCC patients of Caucasian, African-American, or Asian ethnicity. (</a:t>
            </a:r>
            <a:r>
              <a:rPr lang="en-US" altLang="zh-CN" sz="6600" b="1" dirty="0"/>
              <a:t>D</a:t>
            </a:r>
            <a:r>
              <a:rPr lang="en-US" altLang="zh-CN" sz="6600" dirty="0"/>
              <a:t>) Boxplot showing relative expression levels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healthy individuals of either gender or in male or female HNSCC patients. (</a:t>
            </a:r>
            <a:r>
              <a:rPr lang="en-US" altLang="zh-CN" sz="6600" b="1" dirty="0"/>
              <a:t>E</a:t>
            </a:r>
            <a:r>
              <a:rPr lang="en-US" altLang="zh-CN" sz="6600" dirty="0"/>
              <a:t>) Relative expression levels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healthy individuals of any age or in HNSCC patients of different age groups. (</a:t>
            </a:r>
            <a:r>
              <a:rPr lang="en-US" altLang="zh-CN" sz="6600" b="1" dirty="0"/>
              <a:t>F</a:t>
            </a:r>
            <a:r>
              <a:rPr lang="en-US" altLang="zh-CN" sz="6600" dirty="0"/>
              <a:t>) Boxplot showing relative expression levels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healthy individuals or in patients with HNSCC of grade 1, 2, 3, or 4. (</a:t>
            </a:r>
            <a:r>
              <a:rPr lang="en-US" altLang="zh-CN" sz="6600" b="1" dirty="0"/>
              <a:t>G</a:t>
            </a:r>
            <a:r>
              <a:rPr lang="en-US" altLang="zh-CN" sz="6600" dirty="0"/>
              <a:t>) Boxplot showing relative expression levels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healthy individuals or in HNSCC patients with or without human papillomavirus (HPV) infection. (</a:t>
            </a:r>
            <a:r>
              <a:rPr lang="en-US" altLang="zh-CN" sz="6600" b="1" dirty="0"/>
              <a:t>H</a:t>
            </a:r>
            <a:r>
              <a:rPr lang="en-US" altLang="zh-CN" sz="6600" dirty="0"/>
              <a:t>) Boxplot showing the relative expression of </a:t>
            </a:r>
            <a:r>
              <a:rPr lang="en-US" altLang="zh-CN" sz="6600" i="1" dirty="0"/>
              <a:t>DFNA5</a:t>
            </a:r>
            <a:r>
              <a:rPr lang="en-US" altLang="zh-CN" sz="6600" dirty="0"/>
              <a:t> in normal individuals or in HNSCC patients based on nodal metastasis status. *P &lt; 0.05, **P &lt; 0.01, ***P &lt; 0.001.</a:t>
            </a:r>
            <a:endParaRPr lang="zh-CN" altLang="zh-CN" sz="6600" dirty="0"/>
          </a:p>
          <a:p>
            <a:pPr algn="just"/>
            <a:endParaRPr lang="zh-CN" alt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9529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6</TotalTime>
  <Words>242</Words>
  <Application>Microsoft Office PowerPoint</Application>
  <PresentationFormat>自定义</PresentationFormat>
  <Paragraphs>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Yu-feng</dc:creator>
  <cp:lastModifiedBy>liu Yu-feng</cp:lastModifiedBy>
  <cp:revision>264</cp:revision>
  <dcterms:created xsi:type="dcterms:W3CDTF">2020-04-21T18:22:56Z</dcterms:created>
  <dcterms:modified xsi:type="dcterms:W3CDTF">2021-06-05T09:38:57Z</dcterms:modified>
</cp:coreProperties>
</file>